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29986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15165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80935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14949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80283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14326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08309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1911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5440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73026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35331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6053D7-554E-4C4F-BF3D-FDDEC800B4A5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E4921-0C67-4461-9940-ADF97ED19C5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5560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99460" y="5986130"/>
            <a:ext cx="522290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Positive mode Base Peak Ion (BPI) chromatogram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Marula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stem ethanol extrac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0FB5CAE-8DA7-44FE-967B-EE591D812B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1237" y="1128515"/>
            <a:ext cx="9452344" cy="4585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8825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4</cp:revision>
  <dcterms:created xsi:type="dcterms:W3CDTF">2017-04-27T07:32:29Z</dcterms:created>
  <dcterms:modified xsi:type="dcterms:W3CDTF">2017-09-21T09:23:25Z</dcterms:modified>
</cp:coreProperties>
</file>